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9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6327"/>
  </p:normalViewPr>
  <p:slideViewPr>
    <p:cSldViewPr snapToGrid="0">
      <p:cViewPr varScale="1">
        <p:scale>
          <a:sx n="128" d="100"/>
          <a:sy n="128" d="100"/>
        </p:scale>
        <p:origin x="48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2950EB3-F51F-C928-DC8A-B1857A91CF4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A8D8FBA7-4CD1-E30C-9F50-F26202EA329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7D71FD3-90A1-0F31-C4C5-651923426A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7096B9-3461-B24E-834D-A02F31AF391C}" type="datetimeFigureOut">
              <a:rPr kumimoji="1" lang="ja-JP" altLang="en-US" smtClean="0"/>
              <a:t>2023/1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515DF29-C7F1-AFF6-6701-E9B57C3441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7561DF3-DEEC-B5B8-D2CF-81E92A84ED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01F931-FC22-5D44-8FB9-F137C72AAC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413835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E872267-CB91-8B6B-E4CD-224193F299E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D68C5E6C-2F4E-4062-433E-07244E9F64B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D6AC9FF-3A86-2051-28FD-9F4F30BC47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7096B9-3461-B24E-834D-A02F31AF391C}" type="datetimeFigureOut">
              <a:rPr kumimoji="1" lang="ja-JP" altLang="en-US" smtClean="0"/>
              <a:t>2023/1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63295C1-E5AD-A306-BEF2-6A85CAFB17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23723EC-2A28-028A-7424-B04772D450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01F931-FC22-5D44-8FB9-F137C72AAC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171962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FCF472F8-690D-1555-B0A4-045315C7B41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F0022B6E-654A-FC84-8143-3A4B61D7128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158D2D0-0B41-DF8F-F06B-3F98DC56CC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7096B9-3461-B24E-834D-A02F31AF391C}" type="datetimeFigureOut">
              <a:rPr kumimoji="1" lang="ja-JP" altLang="en-US" smtClean="0"/>
              <a:t>2023/1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58F36D0-7FF7-8474-3470-4133F12D78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23EA3C4-BCA5-95C2-E46E-98EF989D80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01F931-FC22-5D44-8FB9-F137C72AAC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72728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D5FE6E5-47F3-5256-0D24-C48B65E878E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00940D4-0B05-F193-D160-1066AA065AA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5268B94-6F97-450E-7746-9300B41EC2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7096B9-3461-B24E-834D-A02F31AF391C}" type="datetimeFigureOut">
              <a:rPr kumimoji="1" lang="ja-JP" altLang="en-US" smtClean="0"/>
              <a:t>2023/1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94C0402-C802-2C95-ABD5-407B76ED39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A7E78D1-9E21-00BC-C5C3-4EAF097D4D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01F931-FC22-5D44-8FB9-F137C72AAC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329024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CF6E797-F745-28FC-86E8-734AC89C9D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2032CAF-E10E-D8DE-95FE-A9575AB2FC1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971F8CF-A712-BABB-7B16-A031D21DE3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7096B9-3461-B24E-834D-A02F31AF391C}" type="datetimeFigureOut">
              <a:rPr kumimoji="1" lang="ja-JP" altLang="en-US" smtClean="0"/>
              <a:t>2023/1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395351A-CB2C-36AF-92CA-A769344506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DC3EAAF-0C23-A42E-AC9E-E08AA2031A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01F931-FC22-5D44-8FB9-F137C72AAC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313203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B1E4280-8A62-7087-284D-6A7BF6E3979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ADBADB7-A5E0-BCEE-A324-6A0780141DC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8F93532C-4DF4-02A7-1430-A02FCF29BAA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9C9A93FE-1C0A-A80A-0E8B-0F4D0E25FC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7096B9-3461-B24E-834D-A02F31AF391C}" type="datetimeFigureOut">
              <a:rPr kumimoji="1" lang="ja-JP" altLang="en-US" smtClean="0"/>
              <a:t>2023/1/3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1F41076E-EEA4-D555-B493-9657460024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710ED60-8B10-5B15-5F21-7A2AD7952C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01F931-FC22-5D44-8FB9-F137C72AAC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050879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112FC44-6692-F8AE-70B8-827D95D63F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040E22B6-CB9B-CA1C-E85F-10CD9B2450E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FE5DE352-DE8B-869F-77ED-C90AEB6A1C5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67DF3F99-F25D-EA3A-4256-EA2AFAA5B14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666BE591-522B-80EB-D17E-2A936B336A2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74727192-5273-154F-C21E-BE8A32BDDE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7096B9-3461-B24E-834D-A02F31AF391C}" type="datetimeFigureOut">
              <a:rPr kumimoji="1" lang="ja-JP" altLang="en-US" smtClean="0"/>
              <a:t>2023/1/30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856E70D1-5BCB-B917-50A0-4E27CACBDF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BC2650A2-55B2-61A3-7C66-2973BB94C8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01F931-FC22-5D44-8FB9-F137C72AAC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256289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1F10F7A-B7BB-676A-4306-9D9DB5D0188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6AE680B3-8710-3D0E-AD7F-18B03A6624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7096B9-3461-B24E-834D-A02F31AF391C}" type="datetimeFigureOut">
              <a:rPr kumimoji="1" lang="ja-JP" altLang="en-US" smtClean="0"/>
              <a:t>2023/1/30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04A854F2-1295-1787-0AD0-8CDB73739F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5198AD37-F9B1-EBB4-A54F-6312640AD1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01F931-FC22-5D44-8FB9-F137C72AAC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316774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96BF66D9-272D-F1EB-08E1-54332D0C54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7096B9-3461-B24E-834D-A02F31AF391C}" type="datetimeFigureOut">
              <a:rPr kumimoji="1" lang="ja-JP" altLang="en-US" smtClean="0"/>
              <a:t>2023/1/30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89F22FC0-2722-E968-2BCD-62853FD885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5C760D12-DB7D-9541-EF43-7DFB6C0E18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01F931-FC22-5D44-8FB9-F137C72AAC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619770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33C7FDA-7FED-86D8-DCE0-41E0E21634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D36644C5-BDB4-59E2-4202-F15F66A0DDA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59AFCCEC-B7B5-989E-0746-E6AF4C2F438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4E3F9A3-11C2-2C5C-DCC8-6F689B8229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7096B9-3461-B24E-834D-A02F31AF391C}" type="datetimeFigureOut">
              <a:rPr kumimoji="1" lang="ja-JP" altLang="en-US" smtClean="0"/>
              <a:t>2023/1/3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1AF6178-CBD4-659D-FA68-9F4E2A5624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F533E1A5-05EB-D1D9-8C5F-096212D3EA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01F931-FC22-5D44-8FB9-F137C72AAC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235961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67085B2-02DF-E8BD-997C-76B8DFE9AD3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2E9E8AA7-3883-A9B9-0E3F-CF343C223A1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37F58083-95B1-055C-98D6-21EE45ED29D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EA32524B-E792-46E8-2B9A-8D5B5F5CCC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7096B9-3461-B24E-834D-A02F31AF391C}" type="datetimeFigureOut">
              <a:rPr kumimoji="1" lang="ja-JP" altLang="en-US" smtClean="0"/>
              <a:t>2023/1/3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E8C7DB4-5B42-CC6A-0891-566D093054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634BBC5F-E0DF-4885-9B87-4E044160A7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01F931-FC22-5D44-8FB9-F137C72AAC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37892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CF6EF668-DD64-CD23-8C0F-6815EFFADC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149D193C-A56A-6E68-9729-31AB872C465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F15B7C6-0FE0-DA2D-93B8-D5CE4CEEA4D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7096B9-3461-B24E-834D-A02F31AF391C}" type="datetimeFigureOut">
              <a:rPr kumimoji="1" lang="ja-JP" altLang="en-US" smtClean="0"/>
              <a:t>2023/1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2598650-4971-DA6D-755A-2B7B8D207C3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41D0B7C-FC34-80DD-2524-03765FE369B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01F931-FC22-5D44-8FB9-F137C72AAC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67719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A81CF45B-0315-FD7E-7DF8-A483317FFCFA}"/>
              </a:ext>
            </a:extLst>
          </p:cNvPr>
          <p:cNvSpPr txBox="1"/>
          <p:nvPr/>
        </p:nvSpPr>
        <p:spPr>
          <a:xfrm>
            <a:off x="467139" y="775252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E9D6D4E7-23E6-6F5C-ADCA-30AF02825755}"/>
              </a:ext>
            </a:extLst>
          </p:cNvPr>
          <p:cNvSpPr txBox="1"/>
          <p:nvPr/>
        </p:nvSpPr>
        <p:spPr>
          <a:xfrm>
            <a:off x="6195391" y="775251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48D370AF-16F8-27D8-A2ED-E5B23FDE659F}"/>
              </a:ext>
            </a:extLst>
          </p:cNvPr>
          <p:cNvSpPr txBox="1"/>
          <p:nvPr/>
        </p:nvSpPr>
        <p:spPr>
          <a:xfrm>
            <a:off x="1392270" y="261679"/>
            <a:ext cx="78197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Supplementary Figure 1. </a:t>
            </a:r>
            <a:r>
              <a:rPr kumimoji="1" lang="en-US" altLang="ja-JP" b="1" dirty="0" err="1"/>
              <a:t>AgeAccel</a:t>
            </a:r>
            <a:r>
              <a:rPr kumimoji="1" lang="en-US" altLang="ja-JP" b="1" dirty="0"/>
              <a:t> and number of transplanted cells</a:t>
            </a:r>
            <a:endParaRPr kumimoji="1" lang="ja-JP" altLang="en-US" b="1"/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39BD39DD-8CF3-5044-BD11-F0E88CBC57F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2955" y="1596600"/>
            <a:ext cx="5029200" cy="3657600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1280B65B-112B-6F9E-7724-70D4400D0B6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95391" y="1596600"/>
            <a:ext cx="5029200" cy="3657600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F9D88804-584A-3E1F-7EDD-66EEEBD3E05B}"/>
              </a:ext>
            </a:extLst>
          </p:cNvPr>
          <p:cNvSpPr txBox="1"/>
          <p:nvPr/>
        </p:nvSpPr>
        <p:spPr>
          <a:xfrm>
            <a:off x="811477" y="5579452"/>
            <a:ext cx="10767827" cy="77905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altLang="ja-JP" sz="1200" b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ry Figure legend: </a:t>
            </a:r>
            <a:r>
              <a:rPr lang="en-US" altLang="ja-JP" sz="12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The relationship between </a:t>
            </a:r>
            <a:r>
              <a:rPr lang="en-US" altLang="ja-JP" sz="1200" kern="100" dirty="0" err="1">
                <a:effectLst/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AgeAccel</a:t>
            </a:r>
            <a:r>
              <a:rPr lang="en-US" altLang="ja-JP" sz="12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 and the number of transplanted cells was analyzed using a scatter plot. Neither the number of CD34-positive cells (a) nor the total number of nucleated cells (b) showed a significant association with </a:t>
            </a:r>
            <a:r>
              <a:rPr lang="en-US" altLang="ja-JP" sz="1200" kern="100" dirty="0" err="1">
                <a:effectLst/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AgeAccel</a:t>
            </a:r>
            <a:r>
              <a:rPr lang="en-US" altLang="ja-JP" sz="12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.</a:t>
            </a:r>
            <a:endParaRPr lang="ja-JP" altLang="ja-JP" sz="12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599857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59</Words>
  <Application>Microsoft Macintosh PowerPoint</Application>
  <PresentationFormat>ワイド画面</PresentationFormat>
  <Paragraphs>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游明朝</vt:lpstr>
      <vt:lpstr>Arial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鬼塚　真仁</dc:creator>
  <cp:lastModifiedBy>鬼塚　真仁</cp:lastModifiedBy>
  <cp:revision>2</cp:revision>
  <dcterms:created xsi:type="dcterms:W3CDTF">2022-09-12T04:17:30Z</dcterms:created>
  <dcterms:modified xsi:type="dcterms:W3CDTF">2023-01-30T09:54:51Z</dcterms:modified>
</cp:coreProperties>
</file>